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 autoCompressPictures="0">
  <p:sldMasterIdLst>
    <p:sldMasterId id="2147483708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embeddedFontLst>
    <p:embeddedFont>
      <p:font typeface="游ゴシック" panose="020B0400000000000000" pitchFamily="34" charset="-128"/>
      <p:regular r:id="rId4"/>
      <p:bold r:id="rId5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06"/>
    <p:restoredTop sz="94635"/>
  </p:normalViewPr>
  <p:slideViewPr>
    <p:cSldViewPr snapToGrid="0">
      <p:cViewPr>
        <p:scale>
          <a:sx n="97" d="100"/>
          <a:sy n="97" d="100"/>
        </p:scale>
        <p:origin x="1888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font" Target="fonts/font2.fntdata"/><Relationship Id="rId10" Type="http://schemas.microsoft.com/office/2016/11/relationships/changesInfo" Target="changesInfos/changesInfo1.xml"/><Relationship Id="rId4" Type="http://schemas.openxmlformats.org/officeDocument/2006/relationships/font" Target="fonts/font1.fntdata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ji Suzuki" userId="5e60f382357cc5ca" providerId="LiveId" clId="{F991ED9F-DC50-5901-B850-E24272BE1518}"/>
    <pc:docChg chg="undo redo custSel modSld modMainMaster modNotesMaster">
      <pc:chgData name="Koji Suzuki" userId="5e60f382357cc5ca" providerId="LiveId" clId="{F991ED9F-DC50-5901-B850-E24272BE1518}" dt="2026-01-23T05:01:19.924" v="1016"/>
      <pc:docMkLst>
        <pc:docMk/>
      </pc:docMkLst>
      <pc:sldChg chg="addSp delSp modSp mod modNotes">
        <pc:chgData name="Koji Suzuki" userId="5e60f382357cc5ca" providerId="LiveId" clId="{F991ED9F-DC50-5901-B850-E24272BE1518}" dt="2026-01-23T05:01:19.924" v="1016"/>
        <pc:sldMkLst>
          <pc:docMk/>
          <pc:sldMk cId="933749122" sldId="256"/>
        </pc:sldMkLst>
        <pc:spChg chg="add mod">
          <ac:chgData name="Koji Suzuki" userId="5e60f382357cc5ca" providerId="LiveId" clId="{F991ED9F-DC50-5901-B850-E24272BE1518}" dt="2026-01-22T12:59:45.510" v="921" actId="20577"/>
          <ac:spMkLst>
            <pc:docMk/>
            <pc:sldMk cId="933749122" sldId="256"/>
            <ac:spMk id="5" creationId="{91FC80B8-2DD1-AE46-7C99-9C1355770857}"/>
          </ac:spMkLst>
        </pc:spChg>
        <pc:spChg chg="add mod topLvl">
          <ac:chgData name="Koji Suzuki" userId="5e60f382357cc5ca" providerId="LiveId" clId="{F991ED9F-DC50-5901-B850-E24272BE1518}" dt="2026-01-23T04:55:06.068" v="962" actId="554"/>
          <ac:spMkLst>
            <pc:docMk/>
            <pc:sldMk cId="933749122" sldId="256"/>
            <ac:spMk id="7" creationId="{285E4E86-0E28-7656-9ADA-F2E0FF76F9E2}"/>
          </ac:spMkLst>
        </pc:spChg>
        <pc:spChg chg="add mod topLvl">
          <ac:chgData name="Koji Suzuki" userId="5e60f382357cc5ca" providerId="LiveId" clId="{F991ED9F-DC50-5901-B850-E24272BE1518}" dt="2026-01-23T04:55:30.394" v="983" actId="1035"/>
          <ac:spMkLst>
            <pc:docMk/>
            <pc:sldMk cId="933749122" sldId="256"/>
            <ac:spMk id="8" creationId="{D2094358-37D8-E52B-1B9E-A575D4EE79FB}"/>
          </ac:spMkLst>
        </pc:spChg>
        <pc:spChg chg="add del mod">
          <ac:chgData name="Koji Suzuki" userId="5e60f382357cc5ca" providerId="LiveId" clId="{F991ED9F-DC50-5901-B850-E24272BE1518}" dt="2026-01-23T05:01:19.924" v="1016"/>
          <ac:spMkLst>
            <pc:docMk/>
            <pc:sldMk cId="933749122" sldId="256"/>
            <ac:spMk id="11" creationId="{FB7D669F-06EF-9358-C09E-F0014F25CB22}"/>
          </ac:spMkLst>
        </pc:spChg>
        <pc:grpChg chg="add del mod">
          <ac:chgData name="Koji Suzuki" userId="5e60f382357cc5ca" providerId="LiveId" clId="{F991ED9F-DC50-5901-B850-E24272BE1518}" dt="2026-01-22T12:29:04.964" v="814" actId="165"/>
          <ac:grpSpMkLst>
            <pc:docMk/>
            <pc:sldMk cId="933749122" sldId="256"/>
            <ac:grpSpMk id="37" creationId="{F0D8B18D-C256-0F48-C459-A4C55093BBD5}"/>
          </ac:grpSpMkLst>
        </pc:grpChg>
        <pc:picChg chg="add del mod">
          <ac:chgData name="Koji Suzuki" userId="5e60f382357cc5ca" providerId="LiveId" clId="{F991ED9F-DC50-5901-B850-E24272BE1518}" dt="2026-01-23T04:52:07.148" v="922" actId="478"/>
          <ac:picMkLst>
            <pc:docMk/>
            <pc:sldMk cId="933749122" sldId="256"/>
            <ac:picMk id="2" creationId="{A4D8993F-B038-E3E4-5958-0C950A4BFAE9}"/>
          </ac:picMkLst>
        </pc:picChg>
        <pc:picChg chg="add del mod">
          <ac:chgData name="Koji Suzuki" userId="5e60f382357cc5ca" providerId="LiveId" clId="{F991ED9F-DC50-5901-B850-E24272BE1518}" dt="2026-01-23T04:52:08.413" v="923" actId="478"/>
          <ac:picMkLst>
            <pc:docMk/>
            <pc:sldMk cId="933749122" sldId="256"/>
            <ac:picMk id="3" creationId="{AF4DFACC-1005-268D-5DCD-DCBCCC6D01CE}"/>
          </ac:picMkLst>
        </pc:picChg>
        <pc:picChg chg="add del mod">
          <ac:chgData name="Koji Suzuki" userId="5e60f382357cc5ca" providerId="LiveId" clId="{F991ED9F-DC50-5901-B850-E24272BE1518}" dt="2026-01-23T05:00:23.551" v="984" actId="478"/>
          <ac:picMkLst>
            <pc:docMk/>
            <pc:sldMk cId="933749122" sldId="256"/>
            <ac:picMk id="4" creationId="{75B697DC-4494-829B-A6CC-93C82C8B8095}"/>
          </ac:picMkLst>
        </pc:picChg>
        <pc:picChg chg="add del mod">
          <ac:chgData name="Koji Suzuki" userId="5e60f382357cc5ca" providerId="LiveId" clId="{F991ED9F-DC50-5901-B850-E24272BE1518}" dt="2026-01-23T05:00:24.258" v="985" actId="478"/>
          <ac:picMkLst>
            <pc:docMk/>
            <pc:sldMk cId="933749122" sldId="256"/>
            <ac:picMk id="6" creationId="{192B887B-F507-9FC6-3F13-D81F1A455682}"/>
          </ac:picMkLst>
        </pc:picChg>
        <pc:picChg chg="add mod">
          <ac:chgData name="Koji Suzuki" userId="5e60f382357cc5ca" providerId="LiveId" clId="{F991ED9F-DC50-5901-B850-E24272BE1518}" dt="2026-01-23T05:01:13.623" v="1003" actId="1038"/>
          <ac:picMkLst>
            <pc:docMk/>
            <pc:sldMk cId="933749122" sldId="256"/>
            <ac:picMk id="9" creationId="{A262125E-884A-E6A1-F09C-8778BB1C9202}"/>
          </ac:picMkLst>
        </pc:picChg>
        <pc:picChg chg="add mod">
          <ac:chgData name="Koji Suzuki" userId="5e60f382357cc5ca" providerId="LiveId" clId="{F991ED9F-DC50-5901-B850-E24272BE1518}" dt="2026-01-23T05:01:17.865" v="1014" actId="1037"/>
          <ac:picMkLst>
            <pc:docMk/>
            <pc:sldMk cId="933749122" sldId="256"/>
            <ac:picMk id="10" creationId="{98FD81D4-C73A-98C1-2114-31347ADF198A}"/>
          </ac:picMkLst>
        </pc:picChg>
        <pc:picChg chg="add del mod topLvl">
          <ac:chgData name="Koji Suzuki" userId="5e60f382357cc5ca" providerId="LiveId" clId="{F991ED9F-DC50-5901-B850-E24272BE1518}" dt="2026-01-22T12:29:07.358" v="815" actId="478"/>
          <ac:picMkLst>
            <pc:docMk/>
            <pc:sldMk cId="933749122" sldId="256"/>
            <ac:picMk id="35" creationId="{B431218B-5607-9104-1B61-2BF2AA168CE7}"/>
          </ac:picMkLst>
        </pc:picChg>
        <pc:picChg chg="add del mod topLvl">
          <ac:chgData name="Koji Suzuki" userId="5e60f382357cc5ca" providerId="LiveId" clId="{F991ED9F-DC50-5901-B850-E24272BE1518}" dt="2026-01-22T12:29:09.099" v="816" actId="478"/>
          <ac:picMkLst>
            <pc:docMk/>
            <pc:sldMk cId="933749122" sldId="256"/>
            <ac:picMk id="36" creationId="{E4132680-DB0F-AEFB-55B7-7225E29AB37A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5B4075-509F-EA48-B089-74FD2777397E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97824F-439D-3349-A9C3-C20AB359D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075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97824F-439D-3349-A9C3-C20AB359D41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060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63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733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847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1250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680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63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609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556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433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848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63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C76697-2AFD-2B44-9754-8386A9675711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F8831A-DD76-4344-AE4E-A8513B16F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633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85E4E86-0E28-7656-9ADA-F2E0FF76F9E2}"/>
              </a:ext>
            </a:extLst>
          </p:cNvPr>
          <p:cNvSpPr txBox="1"/>
          <p:nvPr/>
        </p:nvSpPr>
        <p:spPr>
          <a:xfrm>
            <a:off x="717798" y="72857"/>
            <a:ext cx="3924000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nd–foot syndrome</a:t>
            </a:r>
          </a:p>
          <a:p>
            <a:pPr algn="ctr"/>
            <a:r>
              <a:rPr kumimoji="1" lang="en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nd–foot skin reaction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2094358-37D8-E52B-1B9E-A575D4EE79FB}"/>
              </a:ext>
            </a:extLst>
          </p:cNvPr>
          <p:cNvSpPr txBox="1"/>
          <p:nvPr/>
        </p:nvSpPr>
        <p:spPr>
          <a:xfrm>
            <a:off x="5212438" y="120982"/>
            <a:ext cx="3924000" cy="584775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neiform rash</a:t>
            </a:r>
            <a:endParaRPr kumimoji="1" lang="ja-JP" altLang="en-US" sz="3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1FC80B8-2DD1-AE46-7C99-9C1355770857}"/>
              </a:ext>
            </a:extLst>
          </p:cNvPr>
          <p:cNvSpPr txBox="1"/>
          <p:nvPr/>
        </p:nvSpPr>
        <p:spPr>
          <a:xfrm>
            <a:off x="48115" y="6459336"/>
            <a:ext cx="990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Standardized explanatory materials that exclude nudging elements.</a:t>
            </a:r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グラフィックス 8">
            <a:extLst>
              <a:ext uri="{FF2B5EF4-FFF2-40B4-BE49-F238E27FC236}">
                <a16:creationId xmlns:a16="http://schemas.microsoft.com/office/drawing/2014/main" id="{A262125E-884A-E6A1-F09C-8778BB1C92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23840" y="749403"/>
            <a:ext cx="4090512" cy="5726717"/>
          </a:xfrm>
          <a:prstGeom prst="rect">
            <a:avLst/>
          </a:prstGeom>
        </p:spPr>
      </p:pic>
      <p:pic>
        <p:nvPicPr>
          <p:cNvPr id="10" name="グラフィックス 9">
            <a:extLst>
              <a:ext uri="{FF2B5EF4-FFF2-40B4-BE49-F238E27FC236}">
                <a16:creationId xmlns:a16="http://schemas.microsoft.com/office/drawing/2014/main" id="{98FD81D4-C73A-98C1-2114-31347ADF19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115907" y="749403"/>
            <a:ext cx="4119730" cy="5726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3749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5</TotalTime>
  <Words>23</Words>
  <Application>Microsoft Macintosh PowerPoint</Application>
  <PresentationFormat>A4 210 x 297 mm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Times New Roman</vt:lpstr>
      <vt:lpstr>Arial</vt:lpstr>
      <vt:lpstr>Aptos Display</vt:lpstr>
      <vt:lpstr>Aptos</vt:lpstr>
      <vt:lpstr>游ゴシック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ji Suzuki</dc:creator>
  <cp:lastModifiedBy>Koji Suzuki</cp:lastModifiedBy>
  <cp:revision>1</cp:revision>
  <dcterms:created xsi:type="dcterms:W3CDTF">2025-10-21T11:00:16Z</dcterms:created>
  <dcterms:modified xsi:type="dcterms:W3CDTF">2026-01-23T05:01:30Z</dcterms:modified>
</cp:coreProperties>
</file>